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92" r:id="rId2"/>
    <p:sldId id="300" r:id="rId3"/>
    <p:sldId id="303" r:id="rId4"/>
    <p:sldId id="301" r:id="rId5"/>
    <p:sldId id="302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AAEA3DF-D2D6-7BB6-F534-6BE16F466758}" name="Caroline Kerr" initials="CK" userId="S::cpkerr@wisc.edu::445dcc19-51cc-48f7-9b0d-98bad704782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1033" autoAdjust="0"/>
  </p:normalViewPr>
  <p:slideViewPr>
    <p:cSldViewPr snapToGrid="0">
      <p:cViewPr varScale="1">
        <p:scale>
          <a:sx n="70" d="100"/>
          <a:sy n="70" d="100"/>
        </p:scale>
        <p:origin x="66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B52CC2-4CBE-4F15-8958-8F82BA7DA92D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F1B7F9-C625-4959-B450-AD490C6E4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117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959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66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697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10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432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480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540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205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549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045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164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C11B8-079A-42F3-96F2-AF9D002D46C2}" type="datetimeFigureOut">
              <a:rPr lang="en-US" smtClean="0"/>
              <a:t>1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0A0B1-DEF7-48CE-AE40-1E4B2F0FE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72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9678220-DBF4-4F75-BFA7-6C2E21F40255}"/>
              </a:ext>
            </a:extLst>
          </p:cNvPr>
          <p:cNvSpPr txBox="1">
            <a:spLocks/>
          </p:cNvSpPr>
          <p:nvPr/>
        </p:nvSpPr>
        <p:spPr>
          <a:xfrm>
            <a:off x="148396" y="14988"/>
            <a:ext cx="7352700" cy="8170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1. Acute toxicity profile of </a:t>
            </a:r>
            <a:r>
              <a:rPr lang="en-US" sz="1800" baseline="30000" dirty="0"/>
              <a:t>223</a:t>
            </a:r>
            <a:r>
              <a:rPr lang="en-US" sz="1800" dirty="0"/>
              <a:t>RaCl</a:t>
            </a:r>
            <a:r>
              <a:rPr lang="en-US" sz="1800" baseline="-25000" dirty="0"/>
              <a:t>2</a:t>
            </a:r>
            <a:r>
              <a:rPr lang="en-US" sz="1800" dirty="0"/>
              <a:t>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72EA070-9E4E-9D73-8910-06C03A31F1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5316697"/>
              </p:ext>
            </p:extLst>
          </p:nvPr>
        </p:nvGraphicFramePr>
        <p:xfrm>
          <a:off x="0" y="1057274"/>
          <a:ext cx="7772400" cy="1343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229918" imgH="1596203" progId="Prism10.Document">
                  <p:embed/>
                </p:oleObj>
              </mc:Choice>
              <mc:Fallback>
                <p:oleObj name="Prism 10" r:id="rId2" imgW="9229918" imgH="1596203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72EA070-9E4E-9D73-8910-06C03A31F1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057274"/>
                        <a:ext cx="7772400" cy="1343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9A195C6-4C52-5D6B-2919-417484E3BB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504687"/>
              </p:ext>
            </p:extLst>
          </p:nvPr>
        </p:nvGraphicFramePr>
        <p:xfrm>
          <a:off x="0" y="2790370"/>
          <a:ext cx="7772399" cy="21502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9100269" imgH="2515676" progId="Prism10.Document">
                  <p:embed/>
                </p:oleObj>
              </mc:Choice>
              <mc:Fallback>
                <p:oleObj name="Prism 10" r:id="rId4" imgW="9100269" imgH="2515676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9A195C6-4C52-5D6B-2919-417484E3BB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2790370"/>
                        <a:ext cx="7772399" cy="21502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1E73E49-773F-803A-7B77-ACCD9B271457}"/>
              </a:ext>
            </a:extLst>
          </p:cNvPr>
          <p:cNvSpPr txBox="1"/>
          <p:nvPr/>
        </p:nvSpPr>
        <p:spPr>
          <a:xfrm>
            <a:off x="148396" y="877590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6A5AE38-EE9E-8797-A94D-6EBF413777C1}"/>
              </a:ext>
            </a:extLst>
          </p:cNvPr>
          <p:cNvSpPr txBox="1"/>
          <p:nvPr/>
        </p:nvSpPr>
        <p:spPr>
          <a:xfrm>
            <a:off x="148396" y="2790370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49178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B0E9262B-A54C-6133-11F2-8CD8F9AD3DFA}"/>
              </a:ext>
            </a:extLst>
          </p:cNvPr>
          <p:cNvSpPr txBox="1">
            <a:spLocks/>
          </p:cNvSpPr>
          <p:nvPr/>
        </p:nvSpPr>
        <p:spPr>
          <a:xfrm>
            <a:off x="148396" y="14988"/>
            <a:ext cx="7352700" cy="8170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2. Biodistribution of </a:t>
            </a:r>
            <a:r>
              <a:rPr lang="en-US" sz="1800" baseline="30000" dirty="0"/>
              <a:t>223</a:t>
            </a:r>
            <a:r>
              <a:rPr lang="en-US" sz="1800" dirty="0"/>
              <a:t>RaCl</a:t>
            </a:r>
            <a:r>
              <a:rPr lang="en-US" sz="1800" baseline="-25000" dirty="0"/>
              <a:t>2</a:t>
            </a:r>
            <a:r>
              <a:rPr lang="en-US" sz="1800" dirty="0"/>
              <a:t> in tumor bearing tibiae and isolated tumor compared to background 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4D053C2-5936-FBC6-B865-2B94B49CBE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0037307"/>
              </p:ext>
            </p:extLst>
          </p:nvPr>
        </p:nvGraphicFramePr>
        <p:xfrm>
          <a:off x="148396" y="1291771"/>
          <a:ext cx="4075261" cy="326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8988987" imgH="7204161" progId="Prism10.Document">
                  <p:embed/>
                </p:oleObj>
              </mc:Choice>
              <mc:Fallback>
                <p:oleObj name="Prism 10" r:id="rId2" imgW="8988987" imgH="7204161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4D053C2-5936-FBC6-B865-2B94B49CBE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8396" y="1291771"/>
                        <a:ext cx="4075261" cy="326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A744802-1971-829B-9A24-397060DCE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5214152"/>
              </p:ext>
            </p:extLst>
          </p:nvPr>
        </p:nvGraphicFramePr>
        <p:xfrm>
          <a:off x="376684" y="4867611"/>
          <a:ext cx="6896123" cy="259588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4522862">
                  <a:extLst>
                    <a:ext uri="{9D8B030D-6E8A-4147-A177-3AD203B41FA5}">
                      <a16:colId xmlns:a16="http://schemas.microsoft.com/office/drawing/2014/main" val="169377461"/>
                    </a:ext>
                  </a:extLst>
                </a:gridCol>
                <a:gridCol w="2373261">
                  <a:extLst>
                    <a:ext uri="{9D8B030D-6E8A-4147-A177-3AD203B41FA5}">
                      <a16:colId xmlns:a16="http://schemas.microsoft.com/office/drawing/2014/main" val="97551605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Mean of Ra223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249.8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86888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Mean of background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226.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81826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Difference between means (background – Ra223) ± SEM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-23.56 ± 14.02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9493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95% confidence interval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-53.01 to 5.886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91389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R squared (eta squared)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0.1357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46965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P value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0.1907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033340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200" b="0" u="none" strike="noStrike">
                          <a:effectLst/>
                        </a:rPr>
                        <a:t>P value summary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sz="1200" b="0" u="none" strike="noStrike" dirty="0">
                          <a:effectLst/>
                        </a:rPr>
                        <a:t>ns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0883768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2C52764-65BA-366E-AF98-23F1C48A5BCD}"/>
              </a:ext>
            </a:extLst>
          </p:cNvPr>
          <p:cNvSpPr txBox="1"/>
          <p:nvPr/>
        </p:nvSpPr>
        <p:spPr>
          <a:xfrm>
            <a:off x="148396" y="1291771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74DE8A-9363-A15C-FF76-049920C9B1BF}"/>
              </a:ext>
            </a:extLst>
          </p:cNvPr>
          <p:cNvSpPr txBox="1"/>
          <p:nvPr/>
        </p:nvSpPr>
        <p:spPr>
          <a:xfrm>
            <a:off x="148396" y="4388707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37730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B0DC7FB-5D34-FCD0-04BB-C4804AB42E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5504" y="3343559"/>
            <a:ext cx="2790825" cy="3619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5BDC6C7-CDF2-61A9-179C-975B30E17D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785" y="1301939"/>
            <a:ext cx="3628128" cy="199484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F41D614-C56E-023E-ADA0-6004DF8625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86200" y="1329234"/>
            <a:ext cx="3562226" cy="199484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41F0DE2-604B-13AC-D74E-E882BBC90F93}"/>
              </a:ext>
            </a:extLst>
          </p:cNvPr>
          <p:cNvSpPr txBox="1"/>
          <p:nvPr/>
        </p:nvSpPr>
        <p:spPr>
          <a:xfrm>
            <a:off x="176311" y="1018816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B10A3F-D30A-FFCB-74FE-FD1EE52CE1BE}"/>
              </a:ext>
            </a:extLst>
          </p:cNvPr>
          <p:cNvSpPr txBox="1"/>
          <p:nvPr/>
        </p:nvSpPr>
        <p:spPr>
          <a:xfrm>
            <a:off x="176311" y="3999017"/>
            <a:ext cx="2953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F75A0E2-F148-90E5-44C8-BCE98199FAF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72380" y="6332420"/>
            <a:ext cx="2009775" cy="4191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E0718A0-565B-83BC-46F8-114C4BFE5F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7267" y="4337573"/>
            <a:ext cx="3624706" cy="199484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0A72C83-D48A-DBAB-C9E9-6CBDC9405E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3974" y="4337572"/>
            <a:ext cx="3623551" cy="1994847"/>
          </a:xfrm>
          <a:prstGeom prst="rect">
            <a:avLst/>
          </a:prstGeom>
        </p:spPr>
      </p:pic>
      <p:sp>
        <p:nvSpPr>
          <p:cNvPr id="20" name="Title 1">
            <a:extLst>
              <a:ext uri="{FF2B5EF4-FFF2-40B4-BE49-F238E27FC236}">
                <a16:creationId xmlns:a16="http://schemas.microsoft.com/office/drawing/2014/main" id="{873A90A8-DD0E-CA7C-7BB2-88B1B0818EC2}"/>
              </a:ext>
            </a:extLst>
          </p:cNvPr>
          <p:cNvSpPr txBox="1">
            <a:spLocks/>
          </p:cNvSpPr>
          <p:nvPr/>
        </p:nvSpPr>
        <p:spPr>
          <a:xfrm>
            <a:off x="154746" y="122938"/>
            <a:ext cx="7352700" cy="8170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3. Statistical tests done on survival and tumor growth curves</a:t>
            </a:r>
          </a:p>
        </p:txBody>
      </p:sp>
    </p:spTree>
    <p:extLst>
      <p:ext uri="{BB962C8B-B14F-4D97-AF65-F5344CB8AC3E}">
        <p14:creationId xmlns:p14="http://schemas.microsoft.com/office/powerpoint/2010/main" val="1567104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2458B5E-4745-AF99-5057-E6BDD12BEB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7383385"/>
              </p:ext>
            </p:extLst>
          </p:nvPr>
        </p:nvGraphicFramePr>
        <p:xfrm>
          <a:off x="296703" y="731078"/>
          <a:ext cx="6249871" cy="222504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412827">
                  <a:extLst>
                    <a:ext uri="{9D8B030D-6E8A-4147-A177-3AD203B41FA5}">
                      <a16:colId xmlns:a16="http://schemas.microsoft.com/office/drawing/2014/main" val="1268224763"/>
                    </a:ext>
                  </a:extLst>
                </a:gridCol>
                <a:gridCol w="980661">
                  <a:extLst>
                    <a:ext uri="{9D8B030D-6E8A-4147-A177-3AD203B41FA5}">
                      <a16:colId xmlns:a16="http://schemas.microsoft.com/office/drawing/2014/main" val="1190831562"/>
                    </a:ext>
                  </a:extLst>
                </a:gridCol>
                <a:gridCol w="1192696">
                  <a:extLst>
                    <a:ext uri="{9D8B030D-6E8A-4147-A177-3AD203B41FA5}">
                      <a16:colId xmlns:a16="http://schemas.microsoft.com/office/drawing/2014/main" val="54160659"/>
                    </a:ext>
                  </a:extLst>
                </a:gridCol>
                <a:gridCol w="2663687">
                  <a:extLst>
                    <a:ext uri="{9D8B030D-6E8A-4147-A177-3AD203B41FA5}">
                      <a16:colId xmlns:a16="http://schemas.microsoft.com/office/drawing/2014/main" val="111465465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H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atalog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20052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l-GR" dirty="0"/>
                        <a:t>γ</a:t>
                      </a:r>
                      <a:r>
                        <a:rPr lang="en-US" dirty="0"/>
                        <a:t>H2A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20E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Rabbi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Cell Signaling Technology 97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47243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CD8</a:t>
                      </a:r>
                      <a:r>
                        <a:rPr lang="el-GR" dirty="0"/>
                        <a:t>α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4SM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R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Invitrogen 13-0808-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70270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CD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/>
                        <a:t>4SM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R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Invitrogen 14-9766-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54010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NKG2A/C/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20d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R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Invitrogen 11-5896-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0208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CD11b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M1/70.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R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/>
                        <a:t>Invitrogen MA5-178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8121460"/>
                  </a:ext>
                </a:extLst>
              </a:tr>
            </a:tbl>
          </a:graphicData>
        </a:graphic>
      </p:graphicFrame>
      <p:sp>
        <p:nvSpPr>
          <p:cNvPr id="9" name="Title 1">
            <a:extLst>
              <a:ext uri="{FF2B5EF4-FFF2-40B4-BE49-F238E27FC236}">
                <a16:creationId xmlns:a16="http://schemas.microsoft.com/office/drawing/2014/main" id="{FA873484-8958-C94C-97CF-4E5C37A6BBEC}"/>
              </a:ext>
            </a:extLst>
          </p:cNvPr>
          <p:cNvSpPr txBox="1">
            <a:spLocks/>
          </p:cNvSpPr>
          <p:nvPr/>
        </p:nvSpPr>
        <p:spPr>
          <a:xfrm>
            <a:off x="122996" y="72138"/>
            <a:ext cx="7352700" cy="8170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Table S1. List of antibody utilized for IHC</a:t>
            </a:r>
          </a:p>
        </p:txBody>
      </p:sp>
    </p:spTree>
    <p:extLst>
      <p:ext uri="{BB962C8B-B14F-4D97-AF65-F5344CB8AC3E}">
        <p14:creationId xmlns:p14="http://schemas.microsoft.com/office/powerpoint/2010/main" val="5983145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58F7034-8433-E7E2-038F-BA318AFD24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7278017"/>
              </p:ext>
            </p:extLst>
          </p:nvPr>
        </p:nvGraphicFramePr>
        <p:xfrm>
          <a:off x="296704" y="651565"/>
          <a:ext cx="5181600" cy="296672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2590800">
                  <a:extLst>
                    <a:ext uri="{9D8B030D-6E8A-4147-A177-3AD203B41FA5}">
                      <a16:colId xmlns:a16="http://schemas.microsoft.com/office/drawing/2014/main" val="1809491908"/>
                    </a:ext>
                  </a:extLst>
                </a:gridCol>
                <a:gridCol w="2590800">
                  <a:extLst>
                    <a:ext uri="{9D8B030D-6E8A-4147-A177-3AD203B41FA5}">
                      <a16:colId xmlns:a16="http://schemas.microsoft.com/office/drawing/2014/main" val="134460745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Gen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ssay I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85722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8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3928990_g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18205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Ifnb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0439552_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86234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x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0487796_m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94369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Fa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1204974_m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37515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dl1 (CD27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3048248_m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71365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hc1 (H2-D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4208017_mH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89533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Ddx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m01216853_m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9417132"/>
                  </a:ext>
                </a:extLst>
              </a:tr>
            </a:tbl>
          </a:graphicData>
        </a:graphic>
      </p:graphicFrame>
      <p:sp>
        <p:nvSpPr>
          <p:cNvPr id="4" name="Title 1">
            <a:extLst>
              <a:ext uri="{FF2B5EF4-FFF2-40B4-BE49-F238E27FC236}">
                <a16:creationId xmlns:a16="http://schemas.microsoft.com/office/drawing/2014/main" id="{65DA5C33-9AA7-A059-D91C-21E41A0B227C}"/>
              </a:ext>
            </a:extLst>
          </p:cNvPr>
          <p:cNvSpPr txBox="1">
            <a:spLocks/>
          </p:cNvSpPr>
          <p:nvPr/>
        </p:nvSpPr>
        <p:spPr>
          <a:xfrm>
            <a:off x="215118" y="0"/>
            <a:ext cx="7352700" cy="8170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Table S2. List of TaqMan probes utilized for quantitative RT-PCR experiments</a:t>
            </a:r>
          </a:p>
        </p:txBody>
      </p:sp>
    </p:spTree>
    <p:extLst>
      <p:ext uri="{BB962C8B-B14F-4D97-AF65-F5344CB8AC3E}">
        <p14:creationId xmlns:p14="http://schemas.microsoft.com/office/powerpoint/2010/main" val="3318666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305</TotalTime>
  <Words>181</Words>
  <Application>Microsoft Office PowerPoint</Application>
  <PresentationFormat>Custom</PresentationFormat>
  <Paragraphs>6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Kerr</dc:creator>
  <cp:lastModifiedBy>CYNTHIA CHOI</cp:lastModifiedBy>
  <cp:revision>71</cp:revision>
  <dcterms:created xsi:type="dcterms:W3CDTF">2023-02-28T14:31:28Z</dcterms:created>
  <dcterms:modified xsi:type="dcterms:W3CDTF">2025-12-09T19:27:35Z</dcterms:modified>
</cp:coreProperties>
</file>